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53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E1933F-27FD-42D4-ABAE-E0016BCEBD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E6AC93-B574-4EDC-B579-D537315F60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03D73D-008A-43BF-914A-1A188473B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576EFA-EDA9-40BC-B949-3611799EE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7F0C74-2A8C-4F2B-B436-D38C4FF3AD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1344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448789-10A2-46A2-9EF0-1E87446664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45522D-601B-4C17-BF40-FEA9E437EB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9FC42-3D54-4B9D-B05C-2AF99A804F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563690-0AB0-4ADF-AFB7-C39C43DCC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72E6FB-7049-46B0-83E5-76228D99C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3307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FEB313F-1065-48BD-A951-855E2ED130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E512CF-0CEB-42F6-8F2A-FCF8E3665D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E315C6-9D93-40E6-8308-9EAACBB96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04F22B-F84C-4B98-86B7-BA1FF88D9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6F65E2-9447-49A1-B2A7-E74417855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1565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EC00E5-1143-49A1-B3F7-7962806052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D6FEAA-9A44-445E-86DC-3624A2ACF7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378A86-D808-45A4-8674-760F98532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02FB3F-90BB-4515-94EC-F53D444E6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1F2AA0-9BE4-48E7-A1E3-2425C751E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6165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F90AAF-7E91-4BC8-A0ED-EFC025A45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6AE8FF-EC08-4B97-8EF7-BEE972F4D1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679B6C-C794-481E-83BF-7685297D2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80F077-9402-44C8-B035-1794C5205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6E2AEB-91ED-4DE7-A9B4-384ABA8A8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553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B1BD1-C28D-4122-B864-0C1C10FDBF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D70373-86E1-4C1A-A1D0-9F2CA4C6EC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E4BA96-A5DE-4F31-82EF-48F538893A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F264BA-D856-413A-B1FD-0F84ADF96C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3C58F1-D4BB-4FE1-9488-D61963725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3FFD37-7C16-4647-A979-7E00A4351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4648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44F14A-0022-4F86-AC28-55A90B2E8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BAC857-DF6D-4B6F-8575-00084B90DF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157724-451A-41D5-B7C3-37E615748E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142392-89D9-476D-BDC5-81D676EBED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2BB212-BBBB-454D-9A2D-C77FF00D6A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8AA0C3-980B-4D7B-83F5-6CBC87077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DB576C-5473-4491-876C-1056B623C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07D1A0-DDE3-400F-AC40-AB95B5427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3329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8C4EC-028B-46C6-AA64-B7B23EA8F9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A0DF57-E336-4F97-B4B8-BA6FDFA63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9A471AA-5669-451A-B72E-4CC86527C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54AFEE-127F-43D1-9A7F-6F9B3E0F4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7558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1F86644-ED4E-4C43-80A1-CC505A899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0D8BE9-106F-499E-B083-B72AB6D36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B5F444-1388-403F-A0A9-C61BC3284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78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EDC633-B343-416B-AB68-C8DBC85A1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2DC17D-F024-4AED-9208-57B000E710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70AB8D-CDC2-4CAB-80AB-0FDF07745C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025CB9-214E-417B-9EC8-E58C7D037B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195F2D-E8B8-4EB4-BE7B-AC452B14E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2AAE3C-0FAA-4ADD-8EB6-468B53213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9525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E11902-9542-424E-8B0F-71CAF46CDC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AEB932-D7E4-43C0-8727-59BBC6D20E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6EDEC9-F540-49F1-B3A6-9CF79CA0F4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4A5182-4B4D-4D76-A68B-51E8DC82F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10DBDD-FEFC-4CDE-9B33-AED872F66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D0675E-80FA-4A57-B2D0-4F38B8F5C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2213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F809D1-A994-4C6C-BD8D-B9637505E2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81875A-5FF6-4B56-9E38-2DE9C77288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855BD4-A912-492E-9D25-29347BBCA0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18D10-97FB-45DC-A35F-AB0405111C9B}" type="datetimeFigureOut">
              <a:rPr lang="zh-CN" altLang="en-US" smtClean="0"/>
              <a:t>2019/10/1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2C7EA-71A0-4823-8E30-548BA79C0F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88C727-720E-471E-BFEA-4C3221C936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3432D-1B4B-450E-841A-15B81DC6FF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3894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id="{60DC94AA-7E40-431E-81B8-6539E2AFB1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7186" y="1780789"/>
            <a:ext cx="3857625" cy="26955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47CF4D-4D34-4962-A54E-829A71664980}"/>
              </a:ext>
            </a:extLst>
          </p:cNvPr>
          <p:cNvSpPr txBox="1"/>
          <p:nvPr/>
        </p:nvSpPr>
        <p:spPr>
          <a:xfrm>
            <a:off x="622570" y="680936"/>
            <a:ext cx="976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Figure.1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05D3B5-382F-4570-BEA6-6B0E25F9F44F}"/>
              </a:ext>
            </a:extLst>
          </p:cNvPr>
          <p:cNvSpPr txBox="1"/>
          <p:nvPr/>
        </p:nvSpPr>
        <p:spPr>
          <a:xfrm>
            <a:off x="2386073" y="5077211"/>
            <a:ext cx="84070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Figure.1 legend</a:t>
            </a:r>
          </a:p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qPCR was performed to detect FOXO1’s expression in mRNA level after transfected with control vector and siFOXO1 in MLO-Y4 cells.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3908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8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Soffice</dc:creator>
  <cp:lastModifiedBy>MSoffice</cp:lastModifiedBy>
  <cp:revision>2</cp:revision>
  <dcterms:created xsi:type="dcterms:W3CDTF">2019-10-01T08:24:36Z</dcterms:created>
  <dcterms:modified xsi:type="dcterms:W3CDTF">2019-10-01T09:04:14Z</dcterms:modified>
</cp:coreProperties>
</file>